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467E4-BC4B-4376-B9F0-8AC8E7A8B3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CCF67C-035A-4EEC-809A-4B22FFBD56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18116F-8D97-4AA0-AB2D-E74FDADDDB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6ED70-8F26-4D34-ACA8-9B5F3DE228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FB7A1-3697-4C93-A571-3461A312D2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DEE92-A4CB-459B-890C-4538A8CFC8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DF17F-0B5B-4FE2-AC2E-AF0DB2B775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F69E7D-45F7-4EB7-BA72-B40883CFB2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E2F49-DD81-4DA6-9480-47363963EC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5AF196-A06C-402F-AE23-477268F5CC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CE6E7B-5278-48DC-9D26-B0EF3821D5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74B22F-49F1-4D4C-87E7-95F678A1F0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B313A9-26A5-495B-8DBC-E69A429CFD7F}" type="slidenum">
              <a:rPr b="0" lang="fr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5"/>
          <p:cNvGraphicFramePr/>
          <p:nvPr/>
        </p:nvGraphicFramePr>
        <p:xfrm>
          <a:off x="971640" y="765000"/>
          <a:ext cx="7488000" cy="54007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71640" y="765000"/>
                    <a:ext cx="7488000" cy="5400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 Box 6"/>
          <p:cNvSpPr/>
          <p:nvPr/>
        </p:nvSpPr>
        <p:spPr>
          <a:xfrm>
            <a:off x="2195640" y="5300640"/>
            <a:ext cx="55450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Control      H</a:t>
            </a:r>
            <a:r>
              <a:rPr b="1" lang="fr-CA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fr-CA" sz="1200" spc="-1" strike="noStrike" baseline="-25000">
                <a:solidFill>
                  <a:srgbClr val="000000"/>
                </a:solidFill>
                <a:latin typeface="Arial"/>
              </a:rPr>
              <a:t>2            </a:t>
            </a:r>
            <a:r>
              <a:rPr b="1" lang="fr-CA" sz="1200" spc="-1" strike="noStrike">
                <a:solidFill>
                  <a:srgbClr val="000000"/>
                </a:solidFill>
                <a:latin typeface="Arial"/>
              </a:rPr>
              <a:t>WS-2.5       WS-5         WS-10        WS-20       WS-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8"/>
          <p:cNvSpPr/>
          <p:nvPr/>
        </p:nvSpPr>
        <p:spPr>
          <a:xfrm>
            <a:off x="3851280" y="5589720"/>
            <a:ext cx="3457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9"/>
          <p:cNvSpPr/>
          <p:nvPr/>
        </p:nvSpPr>
        <p:spPr>
          <a:xfrm>
            <a:off x="3995640" y="5589720"/>
            <a:ext cx="33847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fr-CA" sz="1400" spc="-1" strike="noStrike">
                <a:solidFill>
                  <a:srgbClr val="000000"/>
                </a:solidFill>
                <a:latin typeface="Arial"/>
              </a:rPr>
              <a:t>WS (µg/ml) + H</a:t>
            </a:r>
            <a:r>
              <a:rPr b="1" lang="fr-CA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fr-CA" sz="1400" spc="-1" strike="noStrike">
                <a:solidFill>
                  <a:srgbClr val="000000"/>
                </a:solidFill>
                <a:latin typeface="Arial"/>
              </a:rPr>
              <a:t>O</a:t>
            </a:r>
            <a:r>
              <a:rPr b="1" lang="fr-CA" sz="14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fr-CA" sz="1400" spc="-1" strike="noStrike">
                <a:solidFill>
                  <a:srgbClr val="000000"/>
                </a:solidFill>
                <a:latin typeface="Arial"/>
              </a:rPr>
              <a:t> (500 µM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10"/>
          <p:cNvSpPr/>
          <p:nvPr/>
        </p:nvSpPr>
        <p:spPr>
          <a:xfrm>
            <a:off x="2411280" y="364500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400" spc="-1" strike="noStrike">
                <a:solidFill>
                  <a:srgbClr val="000000"/>
                </a:solidFill>
                <a:latin typeface="Arial"/>
              </a:rPr>
              <a:t>* 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1"/>
          <p:cNvSpPr/>
          <p:nvPr/>
        </p:nvSpPr>
        <p:spPr>
          <a:xfrm>
            <a:off x="4716360" y="191628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400" spc="-1" strike="noStrike">
                <a:solidFill>
                  <a:srgbClr val="000000"/>
                </a:solidFill>
                <a:latin typeface="Arial"/>
              </a:rPr>
              <a:t>* 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2"/>
          <p:cNvSpPr/>
          <p:nvPr/>
        </p:nvSpPr>
        <p:spPr>
          <a:xfrm>
            <a:off x="5435640" y="220500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400" spc="-1" strike="noStrike">
                <a:solidFill>
                  <a:srgbClr val="000000"/>
                </a:solidFill>
                <a:latin typeface="Arial"/>
              </a:rPr>
              <a:t>* 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3"/>
          <p:cNvSpPr/>
          <p:nvPr/>
        </p:nvSpPr>
        <p:spPr>
          <a:xfrm>
            <a:off x="6227640" y="263700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400" spc="-1" strike="noStrike">
                <a:solidFill>
                  <a:srgbClr val="000000"/>
                </a:solidFill>
                <a:latin typeface="Arial"/>
              </a:rPr>
              <a:t>* 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4"/>
          <p:cNvSpPr/>
          <p:nvPr/>
        </p:nvSpPr>
        <p:spPr>
          <a:xfrm>
            <a:off x="7020000" y="2708280"/>
            <a:ext cx="576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400" spc="-1" strike="noStrike">
                <a:solidFill>
                  <a:srgbClr val="000000"/>
                </a:solidFill>
                <a:latin typeface="Arial"/>
              </a:rPr>
              <a:t>* 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5"/>
          <p:cNvSpPr/>
          <p:nvPr/>
        </p:nvSpPr>
        <p:spPr>
          <a:xfrm>
            <a:off x="852480" y="189000"/>
            <a:ext cx="300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800" spc="-1" strike="noStrike">
                <a:solidFill>
                  <a:srgbClr val="000000"/>
                </a:solidFill>
                <a:latin typeface="Arial"/>
              </a:rPr>
              <a:t>Supplementary Fig.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Rectangle 1"/>
          <p:cNvSpPr/>
          <p:nvPr/>
        </p:nvSpPr>
        <p:spPr>
          <a:xfrm>
            <a:off x="2286000" y="612720"/>
            <a:ext cx="4572000" cy="57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1. 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 of a treatment with </a:t>
            </a:r>
            <a:r>
              <a:rPr b="0" i="1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n the intracellular level of reactive oxygen species (ROS) in SK-N-SH cells as measured by the fluorescent dye </a:t>
            </a:r>
            <a:r>
              <a:rPr b="0" lang="en-CA" sz="1800" spc="-1" strike="noStrike">
                <a:solidFill>
                  <a:srgbClr val="333300"/>
                </a:solidFill>
                <a:latin typeface="Times New Roman"/>
                <a:ea typeface="Times New Roman"/>
              </a:rPr>
              <a:t>DCF-DA after 1 hour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f treatment with 500 µM of H</a:t>
            </a:r>
            <a:r>
              <a:rPr b="0" lang="en-CA" sz="1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r>
              <a:rPr b="0" lang="en-CA" sz="1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Results are expressed as percentage of control (taken as 100%). Data are means ± SEM of 4-5 separate experiments performed in triplicate at least in each group.  **</a:t>
            </a:r>
            <a:r>
              <a:rPr b="0" i="1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1 </a:t>
            </a:r>
            <a:r>
              <a:rPr b="0" i="1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rsus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</a:t>
            </a:r>
            <a:r>
              <a:rPr b="0" lang="en-CA" sz="1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r>
              <a:rPr b="0" lang="en-CA" sz="18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roup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8T21:50:04Z</dcterms:created>
  <dc:creator>manjeet singh</dc:creator>
  <dc:description/>
  <dc:language>en-US</dc:language>
  <cp:lastModifiedBy>Chris</cp:lastModifiedBy>
  <dcterms:modified xsi:type="dcterms:W3CDTF">2017-07-27T21:11:09Z</dcterms:modified>
  <cp:revision>6</cp:revision>
  <dc:subject/>
  <dc:title>Diapositive 1</dc:title>
</cp:coreProperties>
</file>